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28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How%20much%20difficulty%20do%20you%20have%20with%20activites%20above%20your%20head%202%20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How%20much%20difficulty%20do%20you%20have%20with%20activites%20above%20your%20head%202%20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hD\PhD%20-%20Working%20folder\Working\Pain\Done\Pain%20-%20How%20much%20difficulty%20do%20you%20have%20with%20activites%20above%20your%20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793875765529338"/>
          <c:y val="2.4593703822051588E-2"/>
          <c:w val="0.7640403543307096"/>
          <c:h val="0.79098055276094426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7</c:v>
                  </c:pt>
                  <c:pt idx="4">
                    <c:v>0.14292949787065537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7</c:v>
                  </c:pt>
                  <c:pt idx="4">
                    <c:v>0.14292949787065537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42</c:v>
                </c:pt>
                <c:pt idx="1">
                  <c:v>3.6744186046511627</c:v>
                </c:pt>
                <c:pt idx="2">
                  <c:v>2.7924528301886755</c:v>
                </c:pt>
                <c:pt idx="3">
                  <c:v>2.1851851851851847</c:v>
                </c:pt>
                <c:pt idx="4">
                  <c:v>1.7358490566037741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ymbol val="square"/>
            <c:size val="7"/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08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38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08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38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07</c:v>
                </c:pt>
                <c:pt idx="3">
                  <c:v>2.2549019607843173</c:v>
                </c:pt>
                <c:pt idx="4">
                  <c:v>1.6470588235294121</c:v>
                </c:pt>
              </c:numCache>
            </c:numRef>
          </c:val>
        </c:ser>
        <c:marker val="1"/>
        <c:axId val="83010304"/>
        <c:axId val="83012224"/>
      </c:lineChart>
      <c:catAx>
        <c:axId val="8301030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</a:t>
                </a:r>
                <a:r>
                  <a:rPr lang="en-AU" sz="2000" baseline="0"/>
                  <a:t> Cuff Repair</a:t>
                </a:r>
              </a:p>
            </c:rich>
          </c:tx>
          <c:layout>
            <c:manualLayout>
              <c:xMode val="edge"/>
              <c:yMode val="edge"/>
              <c:x val="0.37513943569553793"/>
              <c:y val="0.90650966920018961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3012224"/>
        <c:crosses val="autoZero"/>
        <c:auto val="1"/>
        <c:lblAlgn val="ctr"/>
        <c:lblOffset val="100"/>
      </c:catAx>
      <c:valAx>
        <c:axId val="83012224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US" sz="2000"/>
                  <a:t>Difficulty with overhead activities</a:t>
                </a:r>
              </a:p>
            </c:rich>
          </c:tx>
          <c:layout>
            <c:manualLayout>
              <c:xMode val="edge"/>
              <c:yMode val="edge"/>
              <c:x val="3.4430555555555603E-2"/>
              <c:y val="0.10502914923038507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3010304"/>
        <c:crosses val="autoZero"/>
        <c:crossBetween val="between"/>
        <c:majorUnit val="1"/>
        <c:minorUnit val="1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969791119860018"/>
          <c:y val="0.6637371504080769"/>
          <c:w val="0.18079866579177623"/>
          <c:h val="8.0112592216360148E-2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793875765529346"/>
          <c:y val="2.4593703822051591E-2"/>
          <c:w val="0.76404035433070983"/>
          <c:h val="0.79098055276094426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23</c:v>
                  </c:pt>
                  <c:pt idx="2">
                    <c:v>0.18538488297990471</c:v>
                  </c:pt>
                  <c:pt idx="3">
                    <c:v>0.16524355544590541</c:v>
                  </c:pt>
                  <c:pt idx="4">
                    <c:v>0.14292949787065545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23</c:v>
                  </c:pt>
                  <c:pt idx="2">
                    <c:v>0.18538488297990471</c:v>
                  </c:pt>
                  <c:pt idx="3">
                    <c:v>0.16524355544590541</c:v>
                  </c:pt>
                  <c:pt idx="4">
                    <c:v>0.14292949787065545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51</c:v>
                </c:pt>
                <c:pt idx="1">
                  <c:v>3.6744186046511627</c:v>
                </c:pt>
                <c:pt idx="2">
                  <c:v>2.7924528301886737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9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38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9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38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12</c:v>
                </c:pt>
                <c:pt idx="3">
                  <c:v>2.2549019607843186</c:v>
                </c:pt>
                <c:pt idx="4">
                  <c:v>1.6470588235294121</c:v>
                </c:pt>
              </c:numCache>
            </c:numRef>
          </c:val>
        </c:ser>
        <c:marker val="1"/>
        <c:axId val="84332928"/>
        <c:axId val="84334848"/>
      </c:lineChart>
      <c:catAx>
        <c:axId val="8433292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</a:t>
                </a:r>
                <a:r>
                  <a:rPr lang="en-AU" sz="2000" baseline="0"/>
                  <a:t> Cuff Repair</a:t>
                </a:r>
              </a:p>
            </c:rich>
          </c:tx>
          <c:layout>
            <c:manualLayout>
              <c:xMode val="edge"/>
              <c:yMode val="edge"/>
              <c:x val="0.37513943569553793"/>
              <c:y val="0.90650966920018961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4334848"/>
        <c:crosses val="autoZero"/>
        <c:auto val="1"/>
        <c:lblAlgn val="ctr"/>
        <c:lblOffset val="100"/>
      </c:catAx>
      <c:valAx>
        <c:axId val="84334848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US" sz="2000"/>
                  <a:t>Difficulty with overhead activities</a:t>
                </a:r>
              </a:p>
            </c:rich>
          </c:tx>
          <c:layout>
            <c:manualLayout>
              <c:xMode val="edge"/>
              <c:yMode val="edge"/>
              <c:x val="3.4430555555555596E-2"/>
              <c:y val="0.1050291492303851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4332928"/>
        <c:crosses val="autoZero"/>
        <c:crossBetween val="between"/>
        <c:majorUnit val="1"/>
        <c:minorUnit val="1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969791119860018"/>
          <c:y val="0.66373715040807735"/>
          <c:w val="0.18079866579177628"/>
          <c:h val="8.0112592216360148E-2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1927756020740621"/>
          <c:y val="0.19503178769320506"/>
          <c:w val="0.70073852498521849"/>
          <c:h val="0.67244065325167912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1</c:v>
                  </c:pt>
                  <c:pt idx="2">
                    <c:v>0.18538488297990471</c:v>
                  </c:pt>
                  <c:pt idx="3">
                    <c:v>0.16524355544590544</c:v>
                  </c:pt>
                  <c:pt idx="4">
                    <c:v>0.14292949787065548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1</c:v>
                  </c:pt>
                  <c:pt idx="2">
                    <c:v>0.18538488297990471</c:v>
                  </c:pt>
                  <c:pt idx="3">
                    <c:v>0.16524355544590544</c:v>
                  </c:pt>
                  <c:pt idx="4">
                    <c:v>0.14292949787065548</c:v>
                  </c:pt>
                </c:numCache>
              </c:numRef>
            </c:minus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1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55</c:v>
                </c:pt>
                <c:pt idx="1">
                  <c:v>3.6744186046511627</c:v>
                </c:pt>
                <c:pt idx="2">
                  <c:v>2.7924528301886733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25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6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25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6</c:v>
                  </c:pt>
                </c:numCache>
              </c:numRef>
            </c:minus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12</c:v>
                </c:pt>
                <c:pt idx="3">
                  <c:v>2.254901960784319</c:v>
                </c:pt>
                <c:pt idx="4">
                  <c:v>1.6470588235294121</c:v>
                </c:pt>
              </c:numCache>
            </c:numRef>
          </c:val>
        </c:ser>
        <c:marker val="1"/>
        <c:axId val="83673088"/>
        <c:axId val="84597376"/>
      </c:lineChart>
      <c:catAx>
        <c:axId val="8367308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US" sz="2000" baseline="0" dirty="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077073790657581"/>
              <c:y val="0.91987955672207722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 baseline="0"/>
            </a:pPr>
            <a:endParaRPr lang="en-US"/>
          </a:p>
        </c:txPr>
        <c:crossAx val="84597376"/>
        <c:crosses val="autoZero"/>
        <c:auto val="1"/>
        <c:lblAlgn val="ctr"/>
        <c:lblOffset val="100"/>
      </c:catAx>
      <c:valAx>
        <c:axId val="84597376"/>
        <c:scaling>
          <c:orientation val="minMax"/>
          <c:max val="4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2000" b="1" i="0" baseline="0" dirty="0"/>
                  <a:t>Difficulty with Overhead </a:t>
                </a:r>
                <a:r>
                  <a:rPr lang="en-AU" sz="2000" b="1" i="0" baseline="0" dirty="0" smtClean="0"/>
                  <a:t>Activities</a:t>
                </a:r>
                <a:endParaRPr lang="en-AU" sz="2000" baseline="0" dirty="0"/>
              </a:p>
            </c:rich>
          </c:tx>
          <c:layout>
            <c:manualLayout>
              <c:xMode val="edge"/>
              <c:yMode val="edge"/>
              <c:x val="4.707514635965631E-2"/>
              <c:y val="0.24596704578594381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crossAx val="83673088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79874455224257623"/>
          <c:y val="0.16419510061242379"/>
          <c:w val="0.13476823983733385"/>
          <c:h val="9.3832020997375531E-2"/>
        </c:manualLayout>
      </c:layout>
      <c:txPr>
        <a:bodyPr/>
        <a:lstStyle/>
        <a:p>
          <a:pPr>
            <a:defRPr sz="1600" baseline="0"/>
          </a:pPr>
          <a:endParaRPr lang="en-US"/>
        </a:p>
      </c:txPr>
    </c:legend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1</cdr:x>
      <cdr:y>0.12201</cdr:y>
    </cdr:from>
    <cdr:to>
      <cdr:x>0.22248</cdr:x>
      <cdr:y>0.91991</cdr:y>
    </cdr:to>
    <cdr:grpSp>
      <cdr:nvGrpSpPr>
        <cdr:cNvPr id="9" name="Group 8"/>
        <cdr:cNvGrpSpPr/>
      </cdr:nvGrpSpPr>
      <cdr:grpSpPr>
        <a:xfrm xmlns:a="http://schemas.openxmlformats.org/drawingml/2006/main">
          <a:off x="780255" y="836745"/>
          <a:ext cx="1259593" cy="5471998"/>
          <a:chOff x="5508104" y="980728"/>
          <a:chExt cx="1259632" cy="5400600"/>
        </a:xfrm>
      </cdr:grpSpPr>
      <cdr:sp macro="" textlink="">
        <cdr:nvSpPr>
          <cdr:cNvPr id="10" name="Rectangle 9"/>
          <cdr:cNvSpPr/>
        </cdr:nvSpPr>
        <cdr:spPr>
          <a:xfrm xmlns:a="http://schemas.openxmlformats.org/drawingml/2006/main">
            <a:off x="5508104" y="980728"/>
            <a:ext cx="1112447" cy="5400600"/>
          </a:xfrm>
          <a:prstGeom xmlns:a="http://schemas.openxmlformats.org/drawingml/2006/main" prst="rect">
            <a:avLst/>
          </a:prstGeom>
          <a:solidFill xmlns:a="http://schemas.openxmlformats.org/drawingml/2006/main">
            <a:sysClr val="window" lastClr="FFFFFF"/>
          </a:solidFill>
          <a:ln xmlns:a="http://schemas.openxmlformats.org/drawingml/2006/main" w="25400" cap="flat" cmpd="sng" algn="ctr">
            <a:solidFill>
              <a:sysClr val="window" lastClr="FFFFFF"/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1" name="TextBox 2"/>
          <cdr:cNvSpPr txBox="1"/>
        </cdr:nvSpPr>
        <cdr:spPr>
          <a:xfrm xmlns:a="http://schemas.openxmlformats.org/drawingml/2006/main">
            <a:off x="5580112" y="1268760"/>
            <a:ext cx="1150756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Very severe</a:t>
            </a:r>
            <a:endParaRPr lang="en-AU" sz="1600" dirty="0"/>
          </a:p>
        </cdr:txBody>
      </cdr:sp>
      <cdr:sp macro="" textlink="">
        <cdr:nvSpPr>
          <cdr:cNvPr id="12" name="TextBox 3"/>
          <cdr:cNvSpPr txBox="1"/>
        </cdr:nvSpPr>
        <cdr:spPr>
          <a:xfrm xmlns:a="http://schemas.openxmlformats.org/drawingml/2006/main">
            <a:off x="5902721" y="2492896"/>
            <a:ext cx="744303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/>
              <a:t>S</a:t>
            </a:r>
            <a:r>
              <a:rPr lang="en-AU" sz="1600" dirty="0" smtClean="0"/>
              <a:t>evere</a:t>
            </a:r>
            <a:endParaRPr lang="en-AU" sz="1600" dirty="0"/>
          </a:p>
        </cdr:txBody>
      </cdr:sp>
      <cdr:sp macro="" textlink="">
        <cdr:nvSpPr>
          <cdr:cNvPr id="13" name="TextBox 4"/>
          <cdr:cNvSpPr txBox="1"/>
        </cdr:nvSpPr>
        <cdr:spPr>
          <a:xfrm xmlns:a="http://schemas.openxmlformats.org/drawingml/2006/main">
            <a:off x="5759114" y="3573016"/>
            <a:ext cx="1008622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oderate</a:t>
            </a:r>
            <a:endParaRPr lang="en-AU" sz="1600" dirty="0"/>
          </a:p>
        </cdr:txBody>
      </cdr:sp>
      <cdr:sp macro="" textlink="">
        <cdr:nvSpPr>
          <cdr:cNvPr id="14" name="TextBox 6"/>
          <cdr:cNvSpPr txBox="1"/>
        </cdr:nvSpPr>
        <cdr:spPr>
          <a:xfrm xmlns:a="http://schemas.openxmlformats.org/drawingml/2006/main">
            <a:off x="6118131" y="4725144"/>
            <a:ext cx="558179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ild</a:t>
            </a:r>
            <a:endParaRPr lang="en-AU" sz="1600" dirty="0"/>
          </a:p>
        </cdr:txBody>
      </cdr:sp>
      <cdr:sp macro="" textlink="">
        <cdr:nvSpPr>
          <cdr:cNvPr id="15" name="TextBox 7"/>
          <cdr:cNvSpPr txBox="1"/>
        </cdr:nvSpPr>
        <cdr:spPr>
          <a:xfrm xmlns:a="http://schemas.openxmlformats.org/drawingml/2006/main">
            <a:off x="6046328" y="5805264"/>
            <a:ext cx="634904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None</a:t>
            </a:r>
            <a:endParaRPr lang="en-AU" sz="16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/>
          <p:cNvGraphicFramePr/>
          <p:nvPr/>
        </p:nvGraphicFramePr>
        <p:xfrm>
          <a:off x="0" y="1124744"/>
          <a:ext cx="9144000" cy="5733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9" name="Group 18"/>
          <p:cNvGrpSpPr/>
          <p:nvPr/>
        </p:nvGrpSpPr>
        <p:grpSpPr>
          <a:xfrm>
            <a:off x="611560" y="764704"/>
            <a:ext cx="1259632" cy="5400600"/>
            <a:chOff x="1331640" y="908720"/>
            <a:chExt cx="1259632" cy="5400600"/>
          </a:xfrm>
        </p:grpSpPr>
        <p:sp>
          <p:nvSpPr>
            <p:cNvPr id="20" name="Rectangle 1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2123728" y="5898758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12" name="Group 11"/>
          <p:cNvGrpSpPr/>
          <p:nvPr/>
        </p:nvGrpSpPr>
        <p:grpSpPr>
          <a:xfrm>
            <a:off x="2555776" y="836712"/>
            <a:ext cx="4248472" cy="144016"/>
            <a:chOff x="3707904" y="3068960"/>
            <a:chExt cx="2736304" cy="144016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/>
          <p:cNvGrpSpPr/>
          <p:nvPr/>
        </p:nvGrpSpPr>
        <p:grpSpPr>
          <a:xfrm>
            <a:off x="2555776" y="476672"/>
            <a:ext cx="5616624" cy="144016"/>
            <a:chOff x="3707904" y="3068960"/>
            <a:chExt cx="2736304" cy="144016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27"/>
          <p:cNvGrpSpPr/>
          <p:nvPr/>
        </p:nvGrpSpPr>
        <p:grpSpPr>
          <a:xfrm>
            <a:off x="5436096" y="1700808"/>
            <a:ext cx="1368152" cy="144016"/>
            <a:chOff x="3707904" y="3068960"/>
            <a:chExt cx="2736304" cy="144016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/>
          <p:nvPr/>
        </p:nvGrpSpPr>
        <p:grpSpPr>
          <a:xfrm>
            <a:off x="6804248" y="2348880"/>
            <a:ext cx="1368152" cy="144016"/>
            <a:chOff x="3707904" y="3068960"/>
            <a:chExt cx="2736304" cy="144016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/>
          <p:cNvSpPr txBox="1"/>
          <p:nvPr/>
        </p:nvSpPr>
        <p:spPr>
          <a:xfrm>
            <a:off x="5004048" y="18864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37" name="TextBox 36"/>
          <p:cNvSpPr txBox="1"/>
          <p:nvPr/>
        </p:nvSpPr>
        <p:spPr>
          <a:xfrm>
            <a:off x="4139952" y="61139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38" name="TextBox 37"/>
          <p:cNvSpPr txBox="1"/>
          <p:nvPr/>
        </p:nvSpPr>
        <p:spPr>
          <a:xfrm>
            <a:off x="5797877" y="147549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39" name="TextBox 38"/>
          <p:cNvSpPr txBox="1"/>
          <p:nvPr/>
        </p:nvSpPr>
        <p:spPr>
          <a:xfrm>
            <a:off x="7238037" y="2123564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grpSp>
        <p:nvGrpSpPr>
          <p:cNvPr id="40" name="Group 39"/>
          <p:cNvGrpSpPr/>
          <p:nvPr/>
        </p:nvGrpSpPr>
        <p:grpSpPr>
          <a:xfrm>
            <a:off x="2555776" y="1206044"/>
            <a:ext cx="1440160" cy="134724"/>
            <a:chOff x="3707904" y="3068960"/>
            <a:chExt cx="2736304" cy="144016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43"/>
          <p:cNvSpPr txBox="1"/>
          <p:nvPr/>
        </p:nvSpPr>
        <p:spPr>
          <a:xfrm>
            <a:off x="3032973" y="98072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</a:t>
            </a:r>
            <a:endParaRPr lang="en-AU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/>
          <p:cNvGraphicFramePr/>
          <p:nvPr/>
        </p:nvGraphicFramePr>
        <p:xfrm>
          <a:off x="0" y="1124744"/>
          <a:ext cx="9144000" cy="5733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8"/>
          <p:cNvGrpSpPr/>
          <p:nvPr/>
        </p:nvGrpSpPr>
        <p:grpSpPr>
          <a:xfrm>
            <a:off x="611560" y="764704"/>
            <a:ext cx="1259632" cy="5400600"/>
            <a:chOff x="1331640" y="908720"/>
            <a:chExt cx="1259632" cy="5400600"/>
          </a:xfrm>
        </p:grpSpPr>
        <p:sp>
          <p:nvSpPr>
            <p:cNvPr id="20" name="Rectangle 1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2123728" y="5898758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-24681" y="0"/>
          <a:ext cx="9168681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55576" y="620688"/>
            <a:ext cx="1259632" cy="5400600"/>
            <a:chOff x="1331640" y="908720"/>
            <a:chExt cx="1259632" cy="5400600"/>
          </a:xfrm>
        </p:grpSpPr>
        <p:sp>
          <p:nvSpPr>
            <p:cNvPr id="10" name="Rectangle 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853292" y="106112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23" name="Group 22"/>
          <p:cNvGrpSpPr/>
          <p:nvPr/>
        </p:nvGrpSpPr>
        <p:grpSpPr>
          <a:xfrm>
            <a:off x="3707904" y="3068960"/>
            <a:ext cx="2736304" cy="144016"/>
            <a:chOff x="3707904" y="3068960"/>
            <a:chExt cx="2736304" cy="144016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53</Words>
  <Application>Microsoft Office PowerPoint</Application>
  <PresentationFormat>On-screen Show (4:3)</PresentationFormat>
  <Paragraphs>2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</dc:creator>
  <cp:lastModifiedBy>Pat</cp:lastModifiedBy>
  <cp:revision>19</cp:revision>
  <dcterms:created xsi:type="dcterms:W3CDTF">2011-11-19T23:44:44Z</dcterms:created>
  <dcterms:modified xsi:type="dcterms:W3CDTF">2012-01-17T06:47:03Z</dcterms:modified>
</cp:coreProperties>
</file>